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323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 varScale="1">
        <p:scale>
          <a:sx n="121" d="100"/>
          <a:sy n="121" d="100"/>
        </p:scale>
        <p:origin x="74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CF381B7-7BF0-A51B-7786-16DD81D3014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06117760-0B72-0E99-10D4-42E18711A9D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5D13C85-7B26-5C03-BC79-37447A8127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71DB1D-1AD7-3444-8FFD-0D20E7C72390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B646B45-0FAF-1071-CC2D-F398B66A3C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2FC4EAE-C09B-22E1-D35C-688FF4F5E4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6264C3-8E5C-9742-A817-FDE73C54D3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00333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59060AF-D601-FE5A-81D4-1B87C52B28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BB41B07-8A87-1DB0-1283-C99C81740D9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B87221D-1431-F230-C1FD-383FA99F36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71DB1D-1AD7-3444-8FFD-0D20E7C72390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A2B6989-3444-DC40-A2D8-A90E029FFE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5FAE18F-3089-7720-0A9C-F115A307A9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6264C3-8E5C-9742-A817-FDE73C54D3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42846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9289355B-9987-7D89-6B05-FC54271FEDF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FDFD598-CB99-7257-31D8-E7F8928F106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AC150F8-DE25-4066-D4E4-B27BEA0E73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71DB1D-1AD7-3444-8FFD-0D20E7C72390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B2D676A-4321-4634-5E6E-BC6531EBF0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709FF82-1E57-0614-1AF8-8C6C4413C7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6264C3-8E5C-9742-A817-FDE73C54D3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35849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3AAED0D-0238-8C1C-8AB2-297E80E51C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0C92C59-E211-566D-6D56-B07F78F4C58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19571FF-5C2E-720C-01DF-ED5AA267AC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71DB1D-1AD7-3444-8FFD-0D20E7C72390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1A04E9E-6A38-0DC1-E6F7-E8435A1426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873D722-FFCA-9E81-0AF2-5865050203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6264C3-8E5C-9742-A817-FDE73C54D3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07469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DBF734F-FD80-8A51-4107-354A695A48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3F49E47-C07B-B675-54AE-271DE8D7585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58614F2-5F1A-34D0-CE80-2F28607F75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71DB1D-1AD7-3444-8FFD-0D20E7C72390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FACE0F3-28C8-B7EE-529D-6F60ACCB6C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6F00D7F-BD3E-1299-6DF9-F2A3E929F0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6264C3-8E5C-9742-A817-FDE73C54D3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6983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49CC15B-804E-F97E-1B14-BAA26D35DF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A632055-6D37-595F-B397-300565F58EF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A173189-F1AF-2193-9689-F7515CB7F2C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50B3139-B646-48E6-19E9-A718E8BB36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71DB1D-1AD7-3444-8FFD-0D20E7C72390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7A93DD5-6C40-9198-BCA6-148DD33310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FCF5AF2-694A-6141-CE49-FB32F2086B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6264C3-8E5C-9742-A817-FDE73C54D3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45641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BB37529-FCD1-46EF-7889-76E9501F0B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ABA34F9-7742-8813-E123-323FD35B86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89FDFF1-16C1-638C-619F-155119A750E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B8BEDCB0-0ECD-CBCD-5C4D-E7FC5FD31D3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6D2F0578-CB98-BFDE-C932-5295B3240FA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0A8E1477-57B4-B7AC-D888-55C9BB353C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71DB1D-1AD7-3444-8FFD-0D20E7C72390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8531E605-087A-3E5C-3676-DC7F53888A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666B4AB8-14FB-EE45-A5F1-ECF5F456BB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6264C3-8E5C-9742-A817-FDE73C54D3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63561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E5C9D5C-F8FA-C103-4E08-FC35814E64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14F3CA2D-1FBF-8A22-3005-F5CD5924A8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71DB1D-1AD7-3444-8FFD-0D20E7C72390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A3278A16-8E15-4A1E-4734-C05AE9A637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D1D8B24B-F016-9EA9-EA64-DD3D688C4C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6264C3-8E5C-9742-A817-FDE73C54D3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12387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677FEB5B-FD65-597E-444D-F31BA6530B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71DB1D-1AD7-3444-8FFD-0D20E7C72390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14CD54FF-1FC7-2C4D-D84A-172F9EF378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CEF15818-B803-9A1A-2145-C4B236A0D1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6264C3-8E5C-9742-A817-FDE73C54D3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04828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2F6DDCE-5F9F-E4DA-795C-CF3539B492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957EBDC-5DBA-F473-6135-A91286D85A2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298A55C-8867-CD07-E329-60AA121CCE9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91F7FA3-4638-742C-065A-776B6574FB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71DB1D-1AD7-3444-8FFD-0D20E7C72390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6900228-7FF2-7C55-9523-37EBE340EF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250E906-A57E-3C33-4115-CC360310B2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6264C3-8E5C-9742-A817-FDE73C54D3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00500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737D394-A7D9-91B3-F521-4253C47413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515CE818-B141-2506-586A-3FBD55AD191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3A16B7C-3007-6923-82EF-674DF515405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2E77D34-2CBB-BF2F-B4E0-7BB1FD2AF2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71DB1D-1AD7-3444-8FFD-0D20E7C72390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BBAE0B7-C33C-929B-5339-370CCD4545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B451B1E-2122-CC18-A66F-CEC62F2C92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6264C3-8E5C-9742-A817-FDE73C54D3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77299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36086628-D3B4-E77D-49CC-51BE476308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66A5D79-DEBD-CBA3-1237-EE5055641F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F9A5235-EB2E-854C-5F47-9F0DB268B98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F71DB1D-1AD7-3444-8FFD-0D20E7C72390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ACDE2DA-D3CB-24FC-01C4-CFB525D777D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53232C9-6DD5-04E3-A96C-E0A8E737344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96264C3-8E5C-9742-A817-FDE73C54D3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81030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65CB65C-2153-FA87-F318-01E01F35C2A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 descr="グラフ, ヒストグラム&#10;&#10;AI 生成コンテンツは誤りを含む可能性があります。">
            <a:extLst>
              <a:ext uri="{FF2B5EF4-FFF2-40B4-BE49-F238E27FC236}">
                <a16:creationId xmlns:a16="http://schemas.microsoft.com/office/drawing/2014/main" id="{DECD6C80-AF26-1FB7-8533-264CAF8EA12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11326" y="1824312"/>
            <a:ext cx="3600000" cy="3600000"/>
          </a:xfrm>
          <a:prstGeom prst="rect">
            <a:avLst/>
          </a:prstGeom>
        </p:spPr>
      </p:pic>
      <p:pic>
        <p:nvPicPr>
          <p:cNvPr id="37" name="図 36" descr="グラフ, 箱ひげ図&#10;&#10;AI 生成コンテンツは誤りを含む可能性があります。">
            <a:extLst>
              <a:ext uri="{FF2B5EF4-FFF2-40B4-BE49-F238E27FC236}">
                <a16:creationId xmlns:a16="http://schemas.microsoft.com/office/drawing/2014/main" id="{ADBE6C35-8670-97E1-B4F5-F79B3E075A6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84010" y="1824312"/>
            <a:ext cx="3600000" cy="3600000"/>
          </a:xfrm>
          <a:prstGeom prst="rect">
            <a:avLst/>
          </a:prstGeom>
        </p:spPr>
      </p:pic>
      <p:pic>
        <p:nvPicPr>
          <p:cNvPr id="33" name="図 32" descr="グラフ, 散布図&#10;&#10;AI 生成コンテンツは誤りを含む可能性があります。">
            <a:extLst>
              <a:ext uri="{FF2B5EF4-FFF2-40B4-BE49-F238E27FC236}">
                <a16:creationId xmlns:a16="http://schemas.microsoft.com/office/drawing/2014/main" id="{C4294650-C2F6-7949-AE15-59979C1965D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20382" y="1824312"/>
            <a:ext cx="3600000" cy="3600000"/>
          </a:xfrm>
          <a:prstGeom prst="rect">
            <a:avLst/>
          </a:prstGeom>
        </p:spPr>
      </p:pic>
      <p:sp>
        <p:nvSpPr>
          <p:cNvPr id="3" name="タイトル 1">
            <a:extLst>
              <a:ext uri="{FF2B5EF4-FFF2-40B4-BE49-F238E27FC236}">
                <a16:creationId xmlns:a16="http://schemas.microsoft.com/office/drawing/2014/main" id="{8BF14D5F-C1E6-9777-D27B-6616DD39A7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0"/>
            <a:ext cx="10515600" cy="1325563"/>
          </a:xfrm>
        </p:spPr>
        <p:txBody>
          <a:bodyPr>
            <a:normAutofit/>
          </a:bodyPr>
          <a:lstStyle/>
          <a:p>
            <a:r>
              <a:rPr kumimoji="1" lang="en-US" altLang="ja-JP" sz="2400" dirty="0">
                <a:latin typeface="Calibri" panose="020F0502020204030204" pitchFamily="34" charset="0"/>
                <a:cs typeface="Calibri" panose="020F0502020204030204" pitchFamily="34" charset="0"/>
              </a:rPr>
              <a:t>Figure S4.</a:t>
            </a:r>
            <a:endParaRPr kumimoji="1" lang="ja-JP" altLang="en-US" sz="24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B08E76C0-2E59-ACEF-7FFB-05E6559A23A2}"/>
              </a:ext>
            </a:extLst>
          </p:cNvPr>
          <p:cNvSpPr txBox="1"/>
          <p:nvPr/>
        </p:nvSpPr>
        <p:spPr>
          <a:xfrm rot="16200000">
            <a:off x="105655" y="3367443"/>
            <a:ext cx="1136530" cy="123111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Overall survival (months)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4" name="表 2">
            <a:extLst>
              <a:ext uri="{FF2B5EF4-FFF2-40B4-BE49-F238E27FC236}">
                <a16:creationId xmlns:a16="http://schemas.microsoft.com/office/drawing/2014/main" id="{FF8ED22F-465D-D6CA-9B24-5C281B565BDC}"/>
              </a:ext>
            </a:extLst>
          </p:cNvPr>
          <p:cNvGraphicFramePr>
            <a:graphicFrameLocks noGrp="1"/>
          </p:cNvGraphicFramePr>
          <p:nvPr/>
        </p:nvGraphicFramePr>
        <p:xfrm>
          <a:off x="9688318" y="2108021"/>
          <a:ext cx="2148132" cy="968399"/>
        </p:xfrm>
        <a:graphic>
          <a:graphicData uri="http://schemas.openxmlformats.org/drawingml/2006/table">
            <a:tbl>
              <a:tblPr firstRow="1" bandRow="1"/>
              <a:tblGrid>
                <a:gridCol w="927663">
                  <a:extLst>
                    <a:ext uri="{9D8B030D-6E8A-4147-A177-3AD203B41FA5}">
                      <a16:colId xmlns:a16="http://schemas.microsoft.com/office/drawing/2014/main" val="2301636050"/>
                    </a:ext>
                  </a:extLst>
                </a:gridCol>
                <a:gridCol w="397827">
                  <a:extLst>
                    <a:ext uri="{9D8B030D-6E8A-4147-A177-3AD203B41FA5}">
                      <a16:colId xmlns:a16="http://schemas.microsoft.com/office/drawing/2014/main" val="4166505210"/>
                    </a:ext>
                  </a:extLst>
                </a:gridCol>
                <a:gridCol w="822642">
                  <a:extLst>
                    <a:ext uri="{9D8B030D-6E8A-4147-A177-3AD203B41FA5}">
                      <a16:colId xmlns:a16="http://schemas.microsoft.com/office/drawing/2014/main" val="532266747"/>
                    </a:ext>
                  </a:extLst>
                </a:gridCol>
              </a:tblGrid>
              <a:tr h="335779"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endParaRPr kumimoji="1" lang="ja-JP" alt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vent</a:t>
                      </a:r>
                      <a:endParaRPr kumimoji="1" lang="ja-JP" alt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</a:t>
                      </a:r>
                    </a:p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95% CI), </a:t>
                      </a:r>
                      <a:r>
                        <a:rPr kumimoji="1" lang="en-US" altLang="ja-JP" sz="800" b="1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</a:t>
                      </a:r>
                      <a:endParaRPr kumimoji="1" lang="ja-JP" alt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35733391"/>
                  </a:ext>
                </a:extLst>
              </a:tr>
              <a:tr h="316310"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800" b="1" dirty="0">
                          <a:solidFill>
                            <a:srgbClr val="E0526B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FI-long (n = 12)</a:t>
                      </a:r>
                      <a:endParaRPr kumimoji="1" lang="ja-JP" altLang="en-US" sz="800" b="1" dirty="0">
                        <a:solidFill>
                          <a:srgbClr val="E0526B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360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800" b="1" dirty="0">
                          <a:solidFill>
                            <a:srgbClr val="E0526B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kumimoji="1" lang="ja-JP" altLang="en-US" sz="800" b="1" dirty="0">
                        <a:solidFill>
                          <a:srgbClr val="E0526B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800" b="1" dirty="0">
                          <a:solidFill>
                            <a:srgbClr val="E0526B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0</a:t>
                      </a:r>
                    </a:p>
                    <a:p>
                      <a:pPr algn="ctr"/>
                      <a:r>
                        <a:rPr kumimoji="1" lang="en-US" altLang="ja-JP" sz="800" b="1" dirty="0">
                          <a:solidFill>
                            <a:srgbClr val="E0526B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2.2–15.9)</a:t>
                      </a:r>
                    </a:p>
                  </a:txBody>
                  <a:tcPr marL="36000" marR="36000" marT="36000" marB="360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45528354"/>
                  </a:ext>
                </a:extLst>
              </a:tr>
              <a:tr h="316310"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FI-short (n = 11)</a:t>
                      </a:r>
                      <a:endParaRPr kumimoji="1" lang="ja-JP" alt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360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kumimoji="1" lang="ja-JP" alt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6</a:t>
                      </a:r>
                    </a:p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.9–8.1)</a:t>
                      </a:r>
                      <a:endParaRPr kumimoji="1" lang="ja-JP" alt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360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7289549"/>
                  </a:ext>
                </a:extLst>
              </a:tr>
            </a:tbl>
          </a:graphicData>
        </a:graphic>
      </p:graphicFrame>
      <p:graphicFrame>
        <p:nvGraphicFramePr>
          <p:cNvPr id="15" name="表 2">
            <a:extLst>
              <a:ext uri="{FF2B5EF4-FFF2-40B4-BE49-F238E27FC236}">
                <a16:creationId xmlns:a16="http://schemas.microsoft.com/office/drawing/2014/main" id="{979D8AA2-6C29-FA90-5A69-B69122E9583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41125228"/>
              </p:ext>
            </p:extLst>
          </p:nvPr>
        </p:nvGraphicFramePr>
        <p:xfrm>
          <a:off x="5785578" y="2108021"/>
          <a:ext cx="2167572" cy="1006339"/>
        </p:xfrm>
        <a:graphic>
          <a:graphicData uri="http://schemas.openxmlformats.org/drawingml/2006/table">
            <a:tbl>
              <a:tblPr firstRow="1" bandRow="1"/>
              <a:tblGrid>
                <a:gridCol w="947103">
                  <a:extLst>
                    <a:ext uri="{9D8B030D-6E8A-4147-A177-3AD203B41FA5}">
                      <a16:colId xmlns:a16="http://schemas.microsoft.com/office/drawing/2014/main" val="2301636050"/>
                    </a:ext>
                  </a:extLst>
                </a:gridCol>
                <a:gridCol w="397827">
                  <a:extLst>
                    <a:ext uri="{9D8B030D-6E8A-4147-A177-3AD203B41FA5}">
                      <a16:colId xmlns:a16="http://schemas.microsoft.com/office/drawing/2014/main" val="4166505210"/>
                    </a:ext>
                  </a:extLst>
                </a:gridCol>
                <a:gridCol w="822642">
                  <a:extLst>
                    <a:ext uri="{9D8B030D-6E8A-4147-A177-3AD203B41FA5}">
                      <a16:colId xmlns:a16="http://schemas.microsoft.com/office/drawing/2014/main" val="532266747"/>
                    </a:ext>
                  </a:extLst>
                </a:gridCol>
              </a:tblGrid>
              <a:tr h="335779"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endParaRPr kumimoji="1" lang="ja-JP" alt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vent</a:t>
                      </a:r>
                      <a:endParaRPr kumimoji="1" lang="ja-JP" alt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</a:t>
                      </a:r>
                    </a:p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95% CI), </a:t>
                      </a:r>
                      <a:r>
                        <a:rPr kumimoji="1" lang="en-US" altLang="ja-JP" sz="800" b="1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</a:t>
                      </a:r>
                      <a:endParaRPr kumimoji="1" lang="ja-JP" alt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35733391"/>
                  </a:ext>
                </a:extLst>
              </a:tr>
              <a:tr h="316310"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800" b="1" dirty="0">
                          <a:solidFill>
                            <a:srgbClr val="E0526B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FI-long (n = 12)</a:t>
                      </a:r>
                      <a:endParaRPr kumimoji="1" lang="ja-JP" altLang="en-US" sz="800" b="1" dirty="0">
                        <a:solidFill>
                          <a:srgbClr val="E0526B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800" b="1" dirty="0">
                          <a:solidFill>
                            <a:srgbClr val="E0526B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kumimoji="1" lang="ja-JP" altLang="en-US" sz="800" b="1" dirty="0">
                        <a:solidFill>
                          <a:srgbClr val="E0526B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800" b="1" dirty="0">
                          <a:solidFill>
                            <a:srgbClr val="E0526B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1</a:t>
                      </a:r>
                    </a:p>
                    <a:p>
                      <a:pPr algn="ctr"/>
                      <a:r>
                        <a:rPr kumimoji="1" lang="en-US" altLang="ja-JP" sz="800" b="1" dirty="0">
                          <a:solidFill>
                            <a:srgbClr val="E0526B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0.7–6.2)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45528354"/>
                  </a:ext>
                </a:extLst>
              </a:tr>
              <a:tr h="316310"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FI-short (n = 11)</a:t>
                      </a:r>
                      <a:endParaRPr kumimoji="1" lang="ja-JP" alt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800" b="1" u="none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kumimoji="1" lang="ja-JP" altLang="en-US" sz="800" b="1" u="none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800" b="1" u="none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</a:t>
                      </a:r>
                    </a:p>
                    <a:p>
                      <a:pPr algn="ctr"/>
                      <a:r>
                        <a:rPr kumimoji="1" lang="en-US" altLang="ja-JP" sz="800" b="1" u="none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0.7–6.2)</a:t>
                      </a:r>
                      <a:endParaRPr kumimoji="1" lang="ja-JP" altLang="en-US" sz="800" b="1" u="none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7289549"/>
                  </a:ext>
                </a:extLst>
              </a:tr>
            </a:tbl>
          </a:graphicData>
        </a:graphic>
      </p:graphicFrame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F733696B-3441-AB77-A66D-D04BDE5722B8}"/>
              </a:ext>
            </a:extLst>
          </p:cNvPr>
          <p:cNvSpPr txBox="1"/>
          <p:nvPr/>
        </p:nvSpPr>
        <p:spPr>
          <a:xfrm>
            <a:off x="412700" y="1798277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a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A40DB42D-9262-14EC-2A59-A5B5517A652D}"/>
              </a:ext>
            </a:extLst>
          </p:cNvPr>
          <p:cNvSpPr txBox="1"/>
          <p:nvPr/>
        </p:nvSpPr>
        <p:spPr>
          <a:xfrm>
            <a:off x="4296000" y="1798277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b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19" name="直線コネクタ 18">
            <a:extLst>
              <a:ext uri="{FF2B5EF4-FFF2-40B4-BE49-F238E27FC236}">
                <a16:creationId xmlns:a16="http://schemas.microsoft.com/office/drawing/2014/main" id="{B1B55F46-BBE7-3245-11EA-BA20E7113D21}"/>
              </a:ext>
            </a:extLst>
          </p:cNvPr>
          <p:cNvCxnSpPr/>
          <p:nvPr/>
        </p:nvCxnSpPr>
        <p:spPr>
          <a:xfrm>
            <a:off x="5668700" y="2947529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直線コネクタ 19">
            <a:extLst>
              <a:ext uri="{FF2B5EF4-FFF2-40B4-BE49-F238E27FC236}">
                <a16:creationId xmlns:a16="http://schemas.microsoft.com/office/drawing/2014/main" id="{317FCFDC-84D6-F8F5-13E5-EEC8F1557011}"/>
              </a:ext>
            </a:extLst>
          </p:cNvPr>
          <p:cNvCxnSpPr>
            <a:cxnSpLocks/>
          </p:cNvCxnSpPr>
          <p:nvPr/>
        </p:nvCxnSpPr>
        <p:spPr>
          <a:xfrm>
            <a:off x="5668700" y="2598754"/>
            <a:ext cx="144000" cy="0"/>
          </a:xfrm>
          <a:prstGeom prst="line">
            <a:avLst/>
          </a:prstGeom>
          <a:ln w="19050">
            <a:solidFill>
              <a:srgbClr val="E0526B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D9E06AC2-4C20-52DE-AF5C-2CDD66DD2022}"/>
              </a:ext>
            </a:extLst>
          </p:cNvPr>
          <p:cNvSpPr txBox="1"/>
          <p:nvPr/>
        </p:nvSpPr>
        <p:spPr>
          <a:xfrm>
            <a:off x="6919451" y="3118967"/>
            <a:ext cx="103425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Log-rank p = 0.41</a:t>
            </a:r>
          </a:p>
        </p:txBody>
      </p:sp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id="{B1FDFF76-2D4F-DDCA-7333-E5B0041376B6}"/>
              </a:ext>
            </a:extLst>
          </p:cNvPr>
          <p:cNvCxnSpPr/>
          <p:nvPr/>
        </p:nvCxnSpPr>
        <p:spPr>
          <a:xfrm>
            <a:off x="9550105" y="2912360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" name="直線コネクタ 22">
            <a:extLst>
              <a:ext uri="{FF2B5EF4-FFF2-40B4-BE49-F238E27FC236}">
                <a16:creationId xmlns:a16="http://schemas.microsoft.com/office/drawing/2014/main" id="{B00D5580-4E44-080A-0B33-8842EC53839E}"/>
              </a:ext>
            </a:extLst>
          </p:cNvPr>
          <p:cNvCxnSpPr>
            <a:cxnSpLocks/>
          </p:cNvCxnSpPr>
          <p:nvPr/>
        </p:nvCxnSpPr>
        <p:spPr>
          <a:xfrm>
            <a:off x="9544318" y="2599467"/>
            <a:ext cx="144000" cy="0"/>
          </a:xfrm>
          <a:prstGeom prst="line">
            <a:avLst/>
          </a:prstGeom>
          <a:ln w="19050">
            <a:solidFill>
              <a:srgbClr val="E0526B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E360AB53-2743-9261-7233-BA15A4218ED5}"/>
              </a:ext>
            </a:extLst>
          </p:cNvPr>
          <p:cNvSpPr txBox="1"/>
          <p:nvPr/>
        </p:nvSpPr>
        <p:spPr>
          <a:xfrm>
            <a:off x="10802751" y="3118967"/>
            <a:ext cx="103425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Log-rank p = 0.16</a:t>
            </a: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F9AB8346-2E9A-5E84-4555-D2A67154B0E9}"/>
              </a:ext>
            </a:extLst>
          </p:cNvPr>
          <p:cNvSpPr txBox="1"/>
          <p:nvPr/>
        </p:nvSpPr>
        <p:spPr>
          <a:xfrm>
            <a:off x="8179300" y="1798277"/>
            <a:ext cx="2824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8A082577-CE76-44C6-4228-52A009463F43}"/>
              </a:ext>
            </a:extLst>
          </p:cNvPr>
          <p:cNvSpPr txBox="1"/>
          <p:nvPr/>
        </p:nvSpPr>
        <p:spPr>
          <a:xfrm>
            <a:off x="1549400" y="4974110"/>
            <a:ext cx="1792478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rastuzumab-free interval (months)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0AEF4CAC-D900-95B3-6613-540FBB39D341}"/>
              </a:ext>
            </a:extLst>
          </p:cNvPr>
          <p:cNvSpPr txBox="1"/>
          <p:nvPr/>
        </p:nvSpPr>
        <p:spPr>
          <a:xfrm>
            <a:off x="2434488" y="2231951"/>
            <a:ext cx="14670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rho = 0.135, p = 0.539</a:t>
            </a:r>
            <a:endParaRPr kumimoji="1" lang="ja-JP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77F599D0-8C15-EDF3-9E02-12863E7C4DDB}"/>
              </a:ext>
            </a:extLst>
          </p:cNvPr>
          <p:cNvSpPr txBox="1"/>
          <p:nvPr/>
        </p:nvSpPr>
        <p:spPr>
          <a:xfrm rot="16200000">
            <a:off x="3776778" y="3322922"/>
            <a:ext cx="1510350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rogression-free survival (%)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DC0684CD-F87D-247B-02E2-84ED81B743F0}"/>
              </a:ext>
            </a:extLst>
          </p:cNvPr>
          <p:cNvSpPr txBox="1"/>
          <p:nvPr/>
        </p:nvSpPr>
        <p:spPr>
          <a:xfrm rot="16200000">
            <a:off x="7882062" y="3324982"/>
            <a:ext cx="1074333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Overall survival (%)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C63DF75E-F336-9289-B83F-1E7FAA13801A}"/>
              </a:ext>
            </a:extLst>
          </p:cNvPr>
          <p:cNvSpPr txBox="1"/>
          <p:nvPr/>
        </p:nvSpPr>
        <p:spPr>
          <a:xfrm>
            <a:off x="5968261" y="4908781"/>
            <a:ext cx="522900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onths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41BFAFDB-B8BE-0760-8C95-1BB8361FE601}"/>
              </a:ext>
            </a:extLst>
          </p:cNvPr>
          <p:cNvSpPr txBox="1"/>
          <p:nvPr/>
        </p:nvSpPr>
        <p:spPr>
          <a:xfrm>
            <a:off x="9835281" y="4908781"/>
            <a:ext cx="522900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onths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172187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9</Words>
  <Application>Microsoft Macintosh PowerPoint</Application>
  <PresentationFormat>ワイド画面</PresentationFormat>
  <Paragraphs>3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Calibri</vt:lpstr>
      <vt:lpstr>Office テーマ</vt:lpstr>
      <vt:lpstr>Figure S4.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oichiro Yoshino</dc:creator>
  <cp:lastModifiedBy>Koichiro Yoshino</cp:lastModifiedBy>
  <cp:revision>3</cp:revision>
  <dcterms:created xsi:type="dcterms:W3CDTF">2026-01-20T00:25:13Z</dcterms:created>
  <dcterms:modified xsi:type="dcterms:W3CDTF">2026-02-24T02:35:45Z</dcterms:modified>
</cp:coreProperties>
</file>